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6E84D-74EB-4A27-B601-7D4B4C93B7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EA376-2B38-4007-97C9-4C7894DEB7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17876-9231-40B2-AAEB-DBB71327FF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C3FBB-192A-4D6B-AD3D-160164B68C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A8579-72D5-4891-98F0-599EB0A736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16913-15CC-4466-B9E3-18C38C2391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13D54-B37B-4801-99B1-C6E570E92F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6B39A-62D1-443F-B324-3AE1984ED2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E95B5-5AA0-4490-A4C8-519A0AD475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3D5EA-1642-413D-8DBE-DAE31D0D63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B5C3A-2DE5-4FB2-B823-FE2AA8E8CC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04320-547B-4E2C-8102-9EE6DAE8D4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320C61-4657-4CEB-8BE6-6515B972EE5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72680" y="475560"/>
            <a:ext cx="385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Oligonucleotide primers used in this stud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24000" y="907920"/>
          <a:ext cx="8229600" cy="5492520"/>
        </p:xfrm>
        <a:graphic>
          <a:graphicData uri="http://schemas.openxmlformats.org/drawingml/2006/table">
            <a:tbl>
              <a:tblPr/>
              <a:tblGrid>
                <a:gridCol w="1640520"/>
                <a:gridCol w="2734920"/>
                <a:gridCol w="3854160"/>
              </a:tblGrid>
              <a:tr h="264600">
                <a:tc gridSpan="3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imer for isolating Rosaceous MYB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53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RE77 5’ 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RE78 5’ RACE N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eneRacer 5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eneRacer 5’ N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RE73 degene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eneRacer 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eneRacer 3’ N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AGAATCGATCCGCAATCGAGTG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CCACCTGTTTCCCAAAAGCCTGTGAAGT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GACTGGAGCACGAGGACACT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GACACTGACATGGACTGAAGGA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CAGGAAAAGTTGCAGRYTTAGRTGGTTGAATTATYTGAR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CTGTCAACGATACGCTACGTAA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CGCTACGTAACGGCATGACA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3240">
                <a:tc gridSpan="3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imer for distinguishing R</a:t>
                      </a:r>
                      <a:r>
                        <a:rPr b="1" lang="en-US" sz="10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&amp; R</a:t>
                      </a:r>
                      <a:r>
                        <a:rPr b="1" lang="en-US" sz="10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6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allel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9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RE162 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RE121 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TGTTGTCGTGCAGAAATGTT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CTGTTTCCCAAAAGCCTGT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4600"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imer for qPCR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ene identifi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Fa Actin 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Fa Actin 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CTAATCGTGAGAAGAT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GCACAATACCAGTAGTA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ananass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Actin (AB116565), also can be used for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vesc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9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Fa qPCR 1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Fa qPCR 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TCAAATCAGGCTTAAAC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TTAAAGACCACCTGTTTC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ananass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MYB10 (EU155162), also can be used for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vesc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MYB10 (EU15516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28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29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TGAGGAAGCCCTGCTGC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ACGACGCAACCCTGCA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ananass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MYB1 (AF401220), also be used for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Fragaria vesc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MY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111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11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TTACAAAGCAGGGTTGAAC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AATCAATGACCACCTGT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avium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'Stella' &amp; 'Rainer' MYB10 (EU15358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Pcr Actin 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 Pcr Actin 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TGACTCAAATCATGTTTGA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TGTGGGAGGGCATACCCTTCA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cerasus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Actin (EE488162), also can be used for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avium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66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667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ATCTCCGTGAAGTTGGGCTTACA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TGTGCAATCCAGAATAGTGAGTT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halcone synthase, designed to the consensus sequence of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cerasifer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(DQ856583) and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persic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(AB09498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70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L27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GCAGCTTGAGTGGGAGGACTACTT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CTCAATGTAATCAGCAGGTGTTTG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Leucoanthocyanidin dioxygenase, designed to the consensus sequence of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cerasifer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(EF683132) and </a:t>
                      </a:r>
                      <a:r>
                        <a:rPr b="0" i="1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Prunus persica</a:t>
                      </a:r>
                      <a:r>
                        <a:rPr b="0" lang="en-NZ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 (EU29221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8T00:50:34Z</dcterms:created>
  <dc:creator>hraaca</dc:creator>
  <dc:description/>
  <dc:language>en-US</dc:language>
  <cp:lastModifiedBy>hraaca</cp:lastModifiedBy>
  <dcterms:modified xsi:type="dcterms:W3CDTF">2010-02-18T21:23:25Z</dcterms:modified>
  <cp:revision>3</cp:revision>
  <dc:subject/>
  <dc:title>Slide 1</dc:title>
</cp:coreProperties>
</file>